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60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>
        <p:scale>
          <a:sx n="100" d="100"/>
          <a:sy n="100" d="100"/>
        </p:scale>
        <p:origin x="240" y="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7E22F0-17DA-6957-CB3D-D1CB7EC201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095457C-3196-832E-30CF-6906DEC2F7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A5E54C-763F-62B1-D748-37FD6ADC3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CB334-741C-D74E-BDF1-0E031B95BC48}" type="datetimeFigureOut">
              <a:rPr lang="en-US" smtClean="0"/>
              <a:t>11/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9D04EC-6842-2BCE-91D0-010E6DA95E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B32483-A37B-8C5C-7AD7-FD4955ECE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51E10-8C7D-2345-BBF6-44A7FC9A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611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2B2886-4253-7510-2DE3-FB0D1D9F02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72D653-5469-759F-2F0F-080A16DF69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184D23-7F4C-CCC9-ADFA-8BD619A23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CB334-741C-D74E-BDF1-0E031B95BC48}" type="datetimeFigureOut">
              <a:rPr lang="en-US" smtClean="0"/>
              <a:t>11/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F56F53-DBBE-9A0E-F177-B131449F7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0810EB-FC5D-3FDB-9F70-AE93E6E37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51E10-8C7D-2345-BBF6-44A7FC9A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125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1ABBEE7-54DA-37F9-FC69-CA068572E3A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74F61A-4E96-4556-1ADB-25181A5A7B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80BB40-5755-258C-4154-15C25D922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CB334-741C-D74E-BDF1-0E031B95BC48}" type="datetimeFigureOut">
              <a:rPr lang="en-US" smtClean="0"/>
              <a:t>11/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63BB39-A3FE-AF85-7B63-5844496329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558BBD-6450-E21D-A103-4908F4AB1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51E10-8C7D-2345-BBF6-44A7FC9A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7838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995857-56D7-4FA2-0A1E-69569E7ABE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04D41D-95C8-8B05-32F1-F118869A07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BF2787-F0BA-82CE-5855-C0F455110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CB334-741C-D74E-BDF1-0E031B95BC48}" type="datetimeFigureOut">
              <a:rPr lang="en-US" smtClean="0"/>
              <a:t>11/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5AADDC-7DC1-8F11-8AA5-EFD33BEA01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DCAEDB-2B06-1CA9-7C22-36C780DA5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51E10-8C7D-2345-BBF6-44A7FC9A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598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8AB65C-6927-4254-9412-47C68EA51B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A7C911-CCDF-0DAA-10EC-15AE00ABA9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584CE1-D313-1631-16F5-235B3C31A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CB334-741C-D74E-BDF1-0E031B95BC48}" type="datetimeFigureOut">
              <a:rPr lang="en-US" smtClean="0"/>
              <a:t>11/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16A7B5-3AB9-44A4-FF3B-EA839A2C8C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CD3B43-B176-7584-9E35-3C54AB1E3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51E10-8C7D-2345-BBF6-44A7FC9A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55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F63EE4-FD55-B7A3-6706-99CFAE00D8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A342A3-2F4A-57A5-733D-0FFA57502C0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F78013-19D1-A3D8-98F4-6B44EF95DA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DE0E86-D636-D8C6-17B6-65B2393E1C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CB334-741C-D74E-BDF1-0E031B95BC48}" type="datetimeFigureOut">
              <a:rPr lang="en-US" smtClean="0"/>
              <a:t>11/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1D9F18-5F83-1B20-75EA-0FE7313DC6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D17C89-356C-3815-4836-B4170515A4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51E10-8C7D-2345-BBF6-44A7FC9A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875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687ED9-0268-45D5-FD2F-ACEBC22451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E73525-70CB-1656-ABEA-E0472CF8FE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74C928-3C01-6F9A-0BA8-420D7450CB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FAF9CEF-C67F-15CD-F836-54CF80390C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6635657-92F4-9BDC-F730-A27C48B476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3B86BD7-DEF6-2EFA-FE03-F3036CC677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CB334-741C-D74E-BDF1-0E031B95BC48}" type="datetimeFigureOut">
              <a:rPr lang="en-US" smtClean="0"/>
              <a:t>11/8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5084E14-F762-B6BA-ACF2-F72DACCE3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43D2EC0-FB15-BFFC-1883-8331634CEB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51E10-8C7D-2345-BBF6-44A7FC9A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4430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8F87A4-7E6C-4229-8A2D-9C1C46CD09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39B40CB-CA4C-531F-3943-4297EFD94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CB334-741C-D74E-BDF1-0E031B95BC48}" type="datetimeFigureOut">
              <a:rPr lang="en-US" smtClean="0"/>
              <a:t>11/8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6D5AA06-D98B-2118-F36F-13C5BBE73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0A4B99E-6C7B-42AF-6F05-624CC019F8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51E10-8C7D-2345-BBF6-44A7FC9A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434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8E61C11-8B68-4F79-96E0-C3237E74F7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CB334-741C-D74E-BDF1-0E031B95BC48}" type="datetimeFigureOut">
              <a:rPr lang="en-US" smtClean="0"/>
              <a:t>11/8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144D2B-D5A0-C998-F0C2-0A50017A3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D23B78-9945-1953-0778-B5F697DF3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51E10-8C7D-2345-BBF6-44A7FC9A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408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76522D-5A94-6FFC-4A5A-62F6416270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1F9F36-AEBF-277C-A123-D38F4F8386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426675-B6F4-F9B8-F101-A9648BB8EB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23D909-79EE-B5F4-BEF6-AF2A4CA77A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CB334-741C-D74E-BDF1-0E031B95BC48}" type="datetimeFigureOut">
              <a:rPr lang="en-US" smtClean="0"/>
              <a:t>11/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061CB9-FABA-39B6-7965-F8C6372B9A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269DAB-0EBF-E535-E9B1-BBE0DE2F6A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51E10-8C7D-2345-BBF6-44A7FC9A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456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0F025E-4D08-FEE3-166D-0E749FE51C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BD0C891-83D8-1697-5F46-D51A2E8BEC5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06742F-6D87-5083-26BF-3108F60B89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049FE4-937A-7825-3AEB-D485D55AE3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CB334-741C-D74E-BDF1-0E031B95BC48}" type="datetimeFigureOut">
              <a:rPr lang="en-US" smtClean="0"/>
              <a:t>11/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A8B74C-1E38-C725-214F-17F71D8B2C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8CC7A8-2409-05BE-3071-F8E428270C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51E10-8C7D-2345-BBF6-44A7FC9A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965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31049E2-EC00-4A56-7276-9C898E499D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5BABF3-B518-3C5B-67B5-88A53CCAD5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0F0A38-4F38-26FC-6A8E-CB2B15FEE6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8FCB334-741C-D74E-BDF1-0E031B95BC48}" type="datetimeFigureOut">
              <a:rPr lang="en-US" smtClean="0"/>
              <a:t>11/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222E83-B656-5DFE-C97A-DB2AA9939C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51EFF3-668D-9DC5-4882-3EF5FDBAB7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6551E10-8C7D-2345-BBF6-44A7FC9AF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5722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g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E57D18-FE94-E788-1A35-C665907B10EE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Media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EDBD923-A659-BC5A-8AF9-AA0FC7ED0D75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5687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EFA6BD-0696-8D56-848A-57549E1F80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Media 1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F5A28405-E4FD-AB6B-9ACA-DD13B1032E0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5524499" y="2286000"/>
            <a:ext cx="6667501" cy="4572000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5B138DB-6E94-B235-CCE6-BCFDE1F4B440}"/>
              </a:ext>
            </a:extLst>
          </p:cNvPr>
          <p:cNvSpPr txBox="1"/>
          <p:nvPr/>
        </p:nvSpPr>
        <p:spPr>
          <a:xfrm>
            <a:off x="400833" y="1871153"/>
            <a:ext cx="4575901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acial shapes and signature evolution from -3 standard deviations (SD) to +3 SD on PC1 from a PCA of the Cri-du-Chat Syndrome sample (</a:t>
            </a:r>
            <a:r>
              <a:rPr lang="en-US" dirty="0" err="1"/>
              <a:t>CdCS</a:t>
            </a:r>
            <a:r>
              <a:rPr lang="en-US" dirty="0"/>
              <a:t>) and matched controls. </a:t>
            </a:r>
            <a:br>
              <a:rPr lang="en-US" dirty="0"/>
            </a:br>
            <a:br>
              <a:rPr lang="en-US" dirty="0"/>
            </a:br>
            <a:r>
              <a:rPr lang="en-US" dirty="0"/>
              <a:t>Red indicates outward deviation compared to an average face locally perpendicular to the surface, blue indicates inward deviation.</a:t>
            </a:r>
          </a:p>
        </p:txBody>
      </p:sp>
    </p:spTree>
    <p:extLst>
      <p:ext uri="{BB962C8B-B14F-4D97-AF65-F5344CB8AC3E}">
        <p14:creationId xmlns:p14="http://schemas.microsoft.com/office/powerpoint/2010/main" val="35644698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EFA6BD-0696-8D56-848A-57549E1F80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Media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5B138DB-6E94-B235-CCE6-BCFDE1F4B440}"/>
              </a:ext>
            </a:extLst>
          </p:cNvPr>
          <p:cNvSpPr txBox="1"/>
          <p:nvPr/>
        </p:nvSpPr>
        <p:spPr>
          <a:xfrm>
            <a:off x="400833" y="1871153"/>
            <a:ext cx="4575901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acial shapes and signature evolution from -3 standard deviations (SD) to +3 SD on PC2 from a PCA of the Cri-du-Chat Syndrome sample (</a:t>
            </a:r>
            <a:r>
              <a:rPr lang="en-US" dirty="0" err="1"/>
              <a:t>CdCS</a:t>
            </a:r>
            <a:r>
              <a:rPr lang="en-US" dirty="0"/>
              <a:t>) and matched controls. </a:t>
            </a:r>
          </a:p>
          <a:p>
            <a:endParaRPr lang="en-US" dirty="0"/>
          </a:p>
          <a:p>
            <a:r>
              <a:rPr lang="en-US" dirty="0"/>
              <a:t>Red indicates outward deviation compared to an average face locally perpendicular to the surface, blue indicates inward deviation.</a:t>
            </a:r>
          </a:p>
        </p:txBody>
      </p:sp>
      <p:pic>
        <p:nvPicPr>
          <p:cNvPr id="8" name="Content Placeholder 7" descr="A face with blue and yellow paint&#10;&#10;Description automatically generated">
            <a:extLst>
              <a:ext uri="{FF2B5EF4-FFF2-40B4-BE49-F238E27FC236}">
                <a16:creationId xmlns:a16="http://schemas.microsoft.com/office/drawing/2014/main" id="{F606D02D-4C23-5B75-4348-F0636A88C31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5524499" y="2286000"/>
            <a:ext cx="6667501" cy="4572000"/>
          </a:xfrm>
        </p:spPr>
      </p:pic>
    </p:spTree>
    <p:extLst>
      <p:ext uri="{BB962C8B-B14F-4D97-AF65-F5344CB8AC3E}">
        <p14:creationId xmlns:p14="http://schemas.microsoft.com/office/powerpoint/2010/main" val="18770392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EFA6BD-0696-8D56-848A-57549E1F80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Media 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5B138DB-6E94-B235-CCE6-BCFDE1F4B440}"/>
              </a:ext>
            </a:extLst>
          </p:cNvPr>
          <p:cNvSpPr txBox="1"/>
          <p:nvPr/>
        </p:nvSpPr>
        <p:spPr>
          <a:xfrm>
            <a:off x="400833" y="1871153"/>
            <a:ext cx="457590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Calibri" panose="020F0502020204030204" pitchFamily="34" charset="0"/>
                <a:ea typeface="Aptos" panose="020B0004020202020204" pitchFamily="34" charset="0"/>
              </a:rPr>
              <a:t>Linear regression of covariate-adjusted Cri-du-Chat Syndrome (</a:t>
            </a:r>
            <a:r>
              <a:rPr lang="en-US" sz="1800" dirty="0" err="1">
                <a:effectLst/>
                <a:latin typeface="Calibri" panose="020F0502020204030204" pitchFamily="34" charset="0"/>
                <a:ea typeface="Aptos" panose="020B0004020202020204" pitchFamily="34" charset="0"/>
              </a:rPr>
              <a:t>CdCS</a:t>
            </a:r>
            <a:r>
              <a:rPr lang="en-US" sz="1800" dirty="0">
                <a:effectLst/>
                <a:latin typeface="Calibri" panose="020F0502020204030204" pitchFamily="34" charset="0"/>
                <a:ea typeface="Aptos" panose="020B0004020202020204" pitchFamily="34" charset="0"/>
              </a:rPr>
              <a:t>) facial shapes on age, showing the </a:t>
            </a:r>
            <a:r>
              <a:rPr lang="en-US" sz="1800" dirty="0" err="1">
                <a:effectLst/>
                <a:latin typeface="Calibri" panose="020F0502020204030204" pitchFamily="34" charset="0"/>
                <a:ea typeface="Aptos" panose="020B0004020202020204" pitchFamily="34" charset="0"/>
              </a:rPr>
              <a:t>CdCS</a:t>
            </a:r>
            <a:r>
              <a:rPr lang="en-US" sz="1800" dirty="0">
                <a:effectLst/>
                <a:latin typeface="Calibri" panose="020F0502020204030204" pitchFamily="34" charset="0"/>
                <a:ea typeface="Aptos" panose="020B0004020202020204" pitchFamily="34" charset="0"/>
              </a:rPr>
              <a:t>-specific phenotypic changes  as individuals get older.</a:t>
            </a:r>
            <a:endParaRPr lang="en-US" dirty="0"/>
          </a:p>
        </p:txBody>
      </p:sp>
      <p:pic>
        <p:nvPicPr>
          <p:cNvPr id="10" name="Picture 9" descr="A white face with eyes closed&#10;&#10;Description automatically generated">
            <a:extLst>
              <a:ext uri="{FF2B5EF4-FFF2-40B4-BE49-F238E27FC236}">
                <a16:creationId xmlns:a16="http://schemas.microsoft.com/office/drawing/2014/main" id="{D2B42E89-82EC-D700-74AB-25744CE3F7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24500" y="2286000"/>
            <a:ext cx="66675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0642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75</TotalTime>
  <Words>145</Words>
  <Application>Microsoft Macintosh PowerPoint</Application>
  <PresentationFormat>Widescreen</PresentationFormat>
  <Paragraphs>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Calibri</vt:lpstr>
      <vt:lpstr>Office Theme</vt:lpstr>
      <vt:lpstr>Supplementary Media</vt:lpstr>
      <vt:lpstr>Supplementary Media 1</vt:lpstr>
      <vt:lpstr>Supplementary Media 2</vt:lpstr>
      <vt:lpstr>Supplementary Media 3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hiel Vanneste</dc:creator>
  <cp:lastModifiedBy>Michiel Vanneste</cp:lastModifiedBy>
  <cp:revision>1</cp:revision>
  <dcterms:created xsi:type="dcterms:W3CDTF">2024-11-08T15:40:31Z</dcterms:created>
  <dcterms:modified xsi:type="dcterms:W3CDTF">2024-11-12T15:56:30Z</dcterms:modified>
</cp:coreProperties>
</file>